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94" r:id="rId2"/>
  </p:sldIdLst>
  <p:sldSz cx="9144000" cy="6858000" type="screen4x3"/>
  <p:notesSz cx="6858000" cy="9313863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60A060"/>
    <a:srgbClr val="CC0000"/>
    <a:srgbClr val="9E7800"/>
    <a:srgbClr val="DAA600"/>
    <a:srgbClr val="CC9900"/>
    <a:srgbClr val="FFFF66"/>
    <a:srgbClr val="FF3300"/>
    <a:srgbClr val="FF7C80"/>
    <a:srgbClr val="684F00"/>
    <a:srgbClr val="5559A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aximized">
    <p:restoredLeft sz="15620" autoAdjust="0"/>
    <p:restoredTop sz="94629" autoAdjust="0"/>
  </p:normalViewPr>
  <p:slideViewPr>
    <p:cSldViewPr>
      <p:cViewPr>
        <p:scale>
          <a:sx n="120" d="100"/>
          <a:sy n="120" d="100"/>
        </p:scale>
        <p:origin x="-1422" y="-7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cholestasis%20biochemical%20characteristics.xls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hijum\docs\ewa\CHolestasis%20paper\rebuttal%20cholestasis%20papaer\necrosis\Copy%20of%20ATP%2005092012%20necrosis%20for%20paper%20200-1.xls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 dirty="0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atp and protein for rebuttal'!$AB$107:$AB$112</c:f>
                <c:numCache>
                  <c:formatCode>General</c:formatCode>
                  <c:ptCount val="6"/>
                  <c:pt idx="0">
                    <c:v>1.3983597568001409</c:v>
                  </c:pt>
                  <c:pt idx="1">
                    <c:v>0.86128052693839696</c:v>
                  </c:pt>
                  <c:pt idx="2">
                    <c:v>1.4337926158900567</c:v>
                  </c:pt>
                  <c:pt idx="3">
                    <c:v>0.62587909476950643</c:v>
                  </c:pt>
                  <c:pt idx="4">
                    <c:v>1.1078059977420265</c:v>
                  </c:pt>
                  <c:pt idx="5">
                    <c:v>1.9608166160033869</c:v>
                  </c:pt>
                </c:numCache>
              </c:numRef>
            </c:plus>
            <c:minus>
              <c:numRef>
                <c:f>'atp and protein for rebuttal'!$AB$107:$AB$112</c:f>
                <c:numCache>
                  <c:formatCode>General</c:formatCode>
                  <c:ptCount val="6"/>
                  <c:pt idx="0">
                    <c:v>1.3983597568001409</c:v>
                  </c:pt>
                  <c:pt idx="1">
                    <c:v>0.86128052693839696</c:v>
                  </c:pt>
                  <c:pt idx="2">
                    <c:v>1.4337926158900567</c:v>
                  </c:pt>
                  <c:pt idx="3">
                    <c:v>0.62587909476950643</c:v>
                  </c:pt>
                  <c:pt idx="4">
                    <c:v>1.1078059977420265</c:v>
                  </c:pt>
                  <c:pt idx="5">
                    <c:v>1.9608166160033869</c:v>
                  </c:pt>
                </c:numCache>
              </c:numRef>
            </c:minus>
          </c:errBars>
          <c:cat>
            <c:strRef>
              <c:f>'atp and protein for rebuttal'!$V$107:$V$112</c:f>
              <c:strCache>
                <c:ptCount val="6"/>
                <c:pt idx="0">
                  <c:v>ctr CsA </c:v>
                </c:pt>
                <c:pt idx="1">
                  <c:v>CsA 40µM</c:v>
                </c:pt>
                <c:pt idx="2">
                  <c:v>ctr CPZ </c:v>
                </c:pt>
                <c:pt idx="3">
                  <c:v>CPZ 20µM</c:v>
                </c:pt>
                <c:pt idx="4">
                  <c:v>ctr EE</c:v>
                </c:pt>
                <c:pt idx="5">
                  <c:v>EE 10µM</c:v>
                </c:pt>
              </c:strCache>
            </c:strRef>
          </c:cat>
          <c:val>
            <c:numRef>
              <c:f>'atp and protein for rebuttal'!$Y$107:$Y$112</c:f>
              <c:numCache>
                <c:formatCode>General</c:formatCode>
                <c:ptCount val="6"/>
                <c:pt idx="0">
                  <c:v>7.8321635830867287</c:v>
                </c:pt>
                <c:pt idx="1">
                  <c:v>8.1957617862312606</c:v>
                </c:pt>
                <c:pt idx="2">
                  <c:v>6.8485337246597018</c:v>
                </c:pt>
                <c:pt idx="3">
                  <c:v>7.5806791034671797</c:v>
                </c:pt>
                <c:pt idx="4">
                  <c:v>6.9706255889471889</c:v>
                </c:pt>
                <c:pt idx="5">
                  <c:v>7.294227989745822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110208"/>
        <c:axId val="110625344"/>
      </c:barChart>
      <c:catAx>
        <c:axId val="110110208"/>
        <c:scaling>
          <c:orientation val="minMax"/>
        </c:scaling>
        <c:delete val="0"/>
        <c:axPos val="b"/>
        <c:numFmt formatCode="General" sourceLinked="1"/>
        <c:majorTickMark val="out"/>
        <c:minorTickMark val="none"/>
        <c:tickLblPos val="nextTo"/>
        <c:crossAx val="110625344"/>
        <c:crosses val="autoZero"/>
        <c:auto val="1"/>
        <c:lblAlgn val="ctr"/>
        <c:lblOffset val="100"/>
        <c:noMultiLvlLbl val="0"/>
      </c:catAx>
      <c:valAx>
        <c:axId val="110625344"/>
        <c:scaling>
          <c:orientation val="minMax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ATP </a:t>
                </a:r>
                <a:r>
                  <a:rPr lang="en-US" b="0" dirty="0" err="1" smtClean="0"/>
                  <a:t>nmol</a:t>
                </a:r>
                <a:r>
                  <a:rPr lang="en-US" b="0" dirty="0" smtClean="0"/>
                  <a:t>/mg </a:t>
                </a:r>
                <a:r>
                  <a:rPr lang="en-US" b="0" dirty="0"/>
                  <a:t>of prote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011020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/>
            </a:pPr>
            <a:r>
              <a:rPr lang="en-US"/>
              <a:t>ATP content</a:t>
            </a:r>
          </a:p>
        </c:rich>
      </c:tx>
      <c:layout/>
      <c:overlay val="1"/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ATP fpr paper'!$O$88:$O$93</c:f>
                <c:numCache>
                  <c:formatCode>General</c:formatCode>
                  <c:ptCount val="6"/>
                  <c:pt idx="0">
                    <c:v>1.3915694778298304</c:v>
                  </c:pt>
                  <c:pt idx="1">
                    <c:v>0.8650965345925955</c:v>
                  </c:pt>
                  <c:pt idx="2">
                    <c:v>0.77607319632787675</c:v>
                  </c:pt>
                  <c:pt idx="3">
                    <c:v>1.2924148794516235</c:v>
                  </c:pt>
                  <c:pt idx="4">
                    <c:v>1.63440364154817</c:v>
                  </c:pt>
                  <c:pt idx="5">
                    <c:v>0.56521277694932226</c:v>
                  </c:pt>
                </c:numCache>
              </c:numRef>
            </c:plus>
            <c:minus>
              <c:numRef>
                <c:f>'ATP fpr paper'!$O$88:$O$93</c:f>
                <c:numCache>
                  <c:formatCode>General</c:formatCode>
                  <c:ptCount val="6"/>
                  <c:pt idx="0">
                    <c:v>1.3915694778298304</c:v>
                  </c:pt>
                  <c:pt idx="1">
                    <c:v>0.8650965345925955</c:v>
                  </c:pt>
                  <c:pt idx="2">
                    <c:v>0.77607319632787675</c:v>
                  </c:pt>
                  <c:pt idx="3">
                    <c:v>1.2924148794516235</c:v>
                  </c:pt>
                  <c:pt idx="4">
                    <c:v>1.63440364154817</c:v>
                  </c:pt>
                  <c:pt idx="5">
                    <c:v>0.56521277694932226</c:v>
                  </c:pt>
                </c:numCache>
              </c:numRef>
            </c:minus>
          </c:errBars>
          <c:cat>
            <c:strRef>
              <c:f>'ATP fpr paper'!$J$88:$J$93</c:f>
              <c:strCache>
                <c:ptCount val="6"/>
                <c:pt idx="0">
                  <c:v>ctr APAP</c:v>
                </c:pt>
                <c:pt idx="1">
                  <c:v>APAP 1mM</c:v>
                </c:pt>
                <c:pt idx="2">
                  <c:v>ctr ISND</c:v>
                </c:pt>
                <c:pt idx="3">
                  <c:v>ISND 1 mM</c:v>
                </c:pt>
                <c:pt idx="4">
                  <c:v>ctr PQ</c:v>
                </c:pt>
                <c:pt idx="5">
                  <c:v>PQ 5 µM</c:v>
                </c:pt>
              </c:strCache>
            </c:strRef>
          </c:cat>
          <c:val>
            <c:numRef>
              <c:f>'ATP fpr paper'!$N$88:$N$93</c:f>
              <c:numCache>
                <c:formatCode>General</c:formatCode>
                <c:ptCount val="6"/>
                <c:pt idx="0">
                  <c:v>8.9443263142940808</c:v>
                </c:pt>
                <c:pt idx="1">
                  <c:v>6.7784147197380138</c:v>
                </c:pt>
                <c:pt idx="2">
                  <c:v>7.5564494178426784</c:v>
                </c:pt>
                <c:pt idx="3">
                  <c:v>7.1724689282794918</c:v>
                </c:pt>
                <c:pt idx="4">
                  <c:v>7.2101522214427476</c:v>
                </c:pt>
                <c:pt idx="5">
                  <c:v>5.856755494813052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110110720"/>
        <c:axId val="110627072"/>
      </c:barChart>
      <c:catAx>
        <c:axId val="110110720"/>
        <c:scaling>
          <c:orientation val="minMax"/>
        </c:scaling>
        <c:delete val="0"/>
        <c:axPos val="b"/>
        <c:majorTickMark val="out"/>
        <c:minorTickMark val="none"/>
        <c:tickLblPos val="nextTo"/>
        <c:crossAx val="110627072"/>
        <c:crosses val="autoZero"/>
        <c:auto val="1"/>
        <c:lblAlgn val="ctr"/>
        <c:lblOffset val="100"/>
        <c:noMultiLvlLbl val="0"/>
      </c:catAx>
      <c:valAx>
        <c:axId val="110627072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b="0"/>
                </a:pPr>
                <a:r>
                  <a:rPr lang="en-US" b="0" dirty="0" smtClean="0"/>
                  <a:t>ATP </a:t>
                </a:r>
                <a:r>
                  <a:rPr lang="en-US" b="0" dirty="0" err="1"/>
                  <a:t>nmol</a:t>
                </a:r>
                <a:r>
                  <a:rPr lang="en-US" b="0" dirty="0"/>
                  <a:t>/mg of protein</a:t>
                </a: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crossAx val="11011072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064" y="0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C1CF9B8-702B-4647-8767-D79E2CF309D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00138" y="698500"/>
            <a:ext cx="4657725" cy="34925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24681"/>
            <a:ext cx="5486400" cy="4190941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846383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064" y="8846383"/>
            <a:ext cx="2972335" cy="4659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3DFD4C5-0EA2-4133-9F34-9F2EFBF58C7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820102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33204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86318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92542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3355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7398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36250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427835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826998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6561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26419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21079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F75EC8-F0D9-43A6-B39E-08880824E880}" type="datetimeFigureOut">
              <a:rPr lang="en-US" smtClean="0"/>
              <a:t>1/4/20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FCEF102-51F4-4422-AEE8-AF6C5A24B5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9377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15245007"/>
              </p:ext>
            </p:extLst>
          </p:nvPr>
        </p:nvGraphicFramePr>
        <p:xfrm>
          <a:off x="762000" y="5334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9" name="Char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574762813"/>
              </p:ext>
            </p:extLst>
          </p:nvPr>
        </p:nvGraphicFramePr>
        <p:xfrm>
          <a:off x="762000" y="3505200"/>
          <a:ext cx="4572000" cy="274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</p:spTree>
    <p:extLst>
      <p:ext uri="{BB962C8B-B14F-4D97-AF65-F5344CB8AC3E}">
        <p14:creationId xmlns:p14="http://schemas.microsoft.com/office/powerpoint/2010/main" val="314457458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513</TotalTime>
  <Words>12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wa Szalowska</dc:creator>
  <cp:lastModifiedBy>Ewa Szalowska</cp:lastModifiedBy>
  <cp:revision>121</cp:revision>
  <cp:lastPrinted>2013-08-03T11:48:09Z</cp:lastPrinted>
  <dcterms:created xsi:type="dcterms:W3CDTF">2013-04-04T11:53:58Z</dcterms:created>
  <dcterms:modified xsi:type="dcterms:W3CDTF">2014-01-04T20:36:50Z</dcterms:modified>
</cp:coreProperties>
</file>